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7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lomka, Marek" userId="b5697613-81d3-4318-a926-46b10f876ab5" providerId="ADAL" clId="{27F310D0-3BCD-446F-BAF4-231697C7807B}"/>
    <pc:docChg chg="undo custSel modSld">
      <pc:chgData name="Slomka, Marek" userId="b5697613-81d3-4318-a926-46b10f876ab5" providerId="ADAL" clId="{27F310D0-3BCD-446F-BAF4-231697C7807B}" dt="2022-09-16T21:43:50.921" v="546" actId="13926"/>
      <pc:docMkLst>
        <pc:docMk/>
      </pc:docMkLst>
      <pc:sldChg chg="addSp modSp mod">
        <pc:chgData name="Slomka, Marek" userId="b5697613-81d3-4318-a926-46b10f876ab5" providerId="ADAL" clId="{27F310D0-3BCD-446F-BAF4-231697C7807B}" dt="2022-09-16T21:43:50.921" v="546" actId="13926"/>
        <pc:sldMkLst>
          <pc:docMk/>
          <pc:sldMk cId="2038887918" sldId="257"/>
        </pc:sldMkLst>
        <pc:spChg chg="add mod">
          <ac:chgData name="Slomka, Marek" userId="b5697613-81d3-4318-a926-46b10f876ab5" providerId="ADAL" clId="{27F310D0-3BCD-446F-BAF4-231697C7807B}" dt="2022-09-16T21:43:50.921" v="546" actId="13926"/>
          <ac:spMkLst>
            <pc:docMk/>
            <pc:sldMk cId="2038887918" sldId="257"/>
            <ac:spMk id="3" creationId="{1F45CC8D-CE37-4AC2-B7F6-C063CA5F23F4}"/>
          </ac:spMkLst>
        </pc:spChg>
        <pc:graphicFrameChg chg="mod">
          <ac:chgData name="Slomka, Marek" userId="b5697613-81d3-4318-a926-46b10f876ab5" providerId="ADAL" clId="{27F310D0-3BCD-446F-BAF4-231697C7807B}" dt="2022-09-16T15:40:09.672" v="544" actId="1076"/>
          <ac:graphicFrameMkLst>
            <pc:docMk/>
            <pc:sldMk cId="2038887918" sldId="257"/>
            <ac:graphicFrameMk id="2" creationId="{42C53DA1-AB90-4A0C-BBD6-F9FB778445B4}"/>
          </ac:graphicFrameMkLst>
        </pc:graphicFrameChg>
      </pc:sldChg>
    </pc:docChg>
  </pc:docChgLst>
  <pc:docChgLst>
    <pc:chgData name="Marek Slomka" userId="b5697613-81d3-4318-a926-46b10f876ab5" providerId="ADAL" clId="{41AF7CE7-5B73-410D-A9AF-4AE036B79745}"/>
    <pc:docChg chg="modSld">
      <pc:chgData name="Marek Slomka" userId="b5697613-81d3-4318-a926-46b10f876ab5" providerId="ADAL" clId="{41AF7CE7-5B73-410D-A9AF-4AE036B79745}" dt="2023-05-16T17:54:49.028" v="3" actId="20577"/>
      <pc:docMkLst>
        <pc:docMk/>
      </pc:docMkLst>
      <pc:sldChg chg="modSp mod">
        <pc:chgData name="Marek Slomka" userId="b5697613-81d3-4318-a926-46b10f876ab5" providerId="ADAL" clId="{41AF7CE7-5B73-410D-A9AF-4AE036B79745}" dt="2023-05-16T17:54:49.028" v="3" actId="20577"/>
        <pc:sldMkLst>
          <pc:docMk/>
          <pc:sldMk cId="2038887918" sldId="257"/>
        </pc:sldMkLst>
        <pc:spChg chg="mod">
          <ac:chgData name="Marek Slomka" userId="b5697613-81d3-4318-a926-46b10f876ab5" providerId="ADAL" clId="{41AF7CE7-5B73-410D-A9AF-4AE036B79745}" dt="2023-05-16T17:54:49.028" v="3" actId="20577"/>
          <ac:spMkLst>
            <pc:docMk/>
            <pc:sldMk cId="2038887918" sldId="257"/>
            <ac:spMk id="3" creationId="{1F45CC8D-CE37-4AC2-B7F6-C063CA5F23F4}"/>
          </ac:spMkLst>
        </pc:spChg>
      </pc:sldChg>
    </pc:docChg>
  </pc:docChgLst>
  <pc:docChgLst>
    <pc:chgData name="Slomka, Marek" userId="b5697613-81d3-4318-a926-46b10f876ab5" providerId="ADAL" clId="{5444721E-7E52-4056-8CDF-8E248B573562}"/>
    <pc:docChg chg="modSld">
      <pc:chgData name="Slomka, Marek" userId="b5697613-81d3-4318-a926-46b10f876ab5" providerId="ADAL" clId="{5444721E-7E52-4056-8CDF-8E248B573562}" dt="2023-04-17T12:06:10.157" v="3" actId="20577"/>
      <pc:docMkLst>
        <pc:docMk/>
      </pc:docMkLst>
      <pc:sldChg chg="modSp mod">
        <pc:chgData name="Slomka, Marek" userId="b5697613-81d3-4318-a926-46b10f876ab5" providerId="ADAL" clId="{5444721E-7E52-4056-8CDF-8E248B573562}" dt="2023-04-17T12:06:10.157" v="3" actId="20577"/>
        <pc:sldMkLst>
          <pc:docMk/>
          <pc:sldMk cId="2038887918" sldId="257"/>
        </pc:sldMkLst>
        <pc:spChg chg="mod">
          <ac:chgData name="Slomka, Marek" userId="b5697613-81d3-4318-a926-46b10f876ab5" providerId="ADAL" clId="{5444721E-7E52-4056-8CDF-8E248B573562}" dt="2023-04-17T12:06:10.157" v="3" actId="20577"/>
          <ac:spMkLst>
            <pc:docMk/>
            <pc:sldMk cId="2038887918" sldId="257"/>
            <ac:spMk id="3" creationId="{1F45CC8D-CE37-4AC2-B7F6-C063CA5F23F4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69D3F2-74F8-4CF7-8610-78D68D4C7FF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848629F-5B9B-43F8-8CFC-CF31D978CCB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60657A-1817-4BA0-9BCD-332D5B117F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CC027F-65FA-4F53-B251-DBD42109946B}" type="datetimeFigureOut">
              <a:rPr lang="en-GB" smtClean="0"/>
              <a:t>16/05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14DA56-D7FA-48FB-88DC-ECA546C21F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A8B9C4-2E1E-4664-8BA0-677EA2DF15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FA3C0-94E3-4D29-B0CC-11C0C24066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42935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1FBA98-CBF8-41AB-A166-AB08ED3F38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3BF953D-BEF8-42D9-81CA-CBEF1CB825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C5B573-E8CF-46EB-A5B2-CB52551B1D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CC027F-65FA-4F53-B251-DBD42109946B}" type="datetimeFigureOut">
              <a:rPr lang="en-GB" smtClean="0"/>
              <a:t>16/05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ECE67E-6857-4CD1-89F0-EF7335C50B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B0D6C8-8975-43AE-89E9-BD6EB39306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FA3C0-94E3-4D29-B0CC-11C0C24066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35178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52E25DC-344F-4339-A5DD-D473FA75FF7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41BF960-8756-48C9-91BA-D63D0A256FC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6633AB-98DF-49C4-AB8B-1931BB2FF6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CC027F-65FA-4F53-B251-DBD42109946B}" type="datetimeFigureOut">
              <a:rPr lang="en-GB" smtClean="0"/>
              <a:t>16/05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5649D5-DFD5-4D40-8CFD-279E06C402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C389E6-F75B-4593-9F4A-32610EB944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FA3C0-94E3-4D29-B0CC-11C0C24066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31267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E788EC-4007-4A49-A0E3-493932C109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0226ADB-EBF9-4997-8A0A-05A8D4A5C7B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9DA3D1-A851-4B1A-824A-0AB52827DF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CC027F-65FA-4F53-B251-DBD42109946B}" type="datetimeFigureOut">
              <a:rPr lang="en-GB" smtClean="0"/>
              <a:t>16/05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3F0E7B-5F88-457F-8B0E-6F6FE48AF0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F9D5A7-7EA5-4DEC-B03F-0597C8C85F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FA3C0-94E3-4D29-B0CC-11C0C24066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79221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A39967-195B-41AC-9DF1-52F50DC230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8364687-EA78-47BF-B220-7419508209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33938F-B4F0-4622-ABB7-5BA053B21B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CC027F-65FA-4F53-B251-DBD42109946B}" type="datetimeFigureOut">
              <a:rPr lang="en-GB" smtClean="0"/>
              <a:t>16/05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7AC0BC-AB74-4547-910D-A1613F7BE5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E28B48-80BD-4F8D-AFF4-FCCF7DF3B9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FA3C0-94E3-4D29-B0CC-11C0C24066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989144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0ADE73-7B0F-4AD9-9BA7-F9C9EE4A08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A8E41F2-6B36-4B69-AC36-A88D82B0475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AA9D89C-3A92-44C7-93D7-2EE5C15EC4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80FC0E-7B14-49C8-A47D-9D7F28FD7C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CC027F-65FA-4F53-B251-DBD42109946B}" type="datetimeFigureOut">
              <a:rPr lang="en-GB" smtClean="0"/>
              <a:t>16/05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7E8422F-FA8E-4B8C-A640-24842D3E71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7E20401-ACE9-4602-AAFD-E398C06F0B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FA3C0-94E3-4D29-B0CC-11C0C24066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75589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DA5C10-F5B6-4053-BEE2-85B4953DCC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AA0FD33-2F01-4063-AC4A-77326C74AE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B304E3A-F5B0-474B-B61F-02311A4D2F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9ED86BD-5CDB-4D4C-B2F8-0E988D2F9B8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BF2E988-75B4-4506-B8A4-9BC2EF2B9DE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69D3CC9-7F30-4B8B-A5A1-D1CCF57C16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CC027F-65FA-4F53-B251-DBD42109946B}" type="datetimeFigureOut">
              <a:rPr lang="en-GB" smtClean="0"/>
              <a:t>16/05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ABAFD1A-FDE1-4D47-BC03-E12B5DFEC1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434AB93-FCFF-4A96-ABC8-FF66F9460D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FA3C0-94E3-4D29-B0CC-11C0C24066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1708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C7431C-A7D3-4E66-9AD3-D7A44439EE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8489302-3C34-4148-AA4E-DF48E1A1ED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CC027F-65FA-4F53-B251-DBD42109946B}" type="datetimeFigureOut">
              <a:rPr lang="en-GB" smtClean="0"/>
              <a:t>16/05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23A55E0-0425-47C9-9918-0054463B57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E0A3BD9-A22D-4374-AF13-203CCA1EC8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FA3C0-94E3-4D29-B0CC-11C0C24066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52959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4B38C8B-79CE-4042-8C15-F2928A1A25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CC027F-65FA-4F53-B251-DBD42109946B}" type="datetimeFigureOut">
              <a:rPr lang="en-GB" smtClean="0"/>
              <a:t>16/05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14964DA-6821-4035-BD83-F4107D842D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A2EEFC2-83B6-4045-8CA6-FE68BD3C80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FA3C0-94E3-4D29-B0CC-11C0C24066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98543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351F20-F7E4-416D-B0DC-EC6947B72F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428A5EC-8860-40AF-A516-0EC9AE81265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8CC4E5F-911F-431A-9FC3-BAFFE11C34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8955791-CEA1-4A2B-85C7-91BF68B2E2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CC027F-65FA-4F53-B251-DBD42109946B}" type="datetimeFigureOut">
              <a:rPr lang="en-GB" smtClean="0"/>
              <a:t>16/05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C55B55B-1640-4781-BB60-970B5F6A77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77072F-71CF-45F4-B55E-F8A7638ACA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FA3C0-94E3-4D29-B0CC-11C0C24066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88057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335A30-0A30-47F2-94C5-F37D4E097E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BF65517-BB78-4CC0-9A72-F30BF4C7E75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E789C5F-AB2F-4CD6-B6D8-8C3A2E1813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586A0A0-691A-4C0B-BE55-69EB708EAC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CC027F-65FA-4F53-B251-DBD42109946B}" type="datetimeFigureOut">
              <a:rPr lang="en-GB" smtClean="0"/>
              <a:t>16/05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4675B9F-6548-43BD-B01F-4324CE95E4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A8CF7E8-1C9E-489D-9A3B-47773139FE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FA3C0-94E3-4D29-B0CC-11C0C24066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60909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BD0B138-84B1-4B67-9C71-201DC191D7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375629E-8F09-43E0-B8C7-BD53B83034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933DAD-73CC-4B71-896C-8AED4BDB2D9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CC027F-65FA-4F53-B251-DBD42109946B}" type="datetimeFigureOut">
              <a:rPr lang="en-GB" smtClean="0"/>
              <a:t>16/05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7467E9-6ED9-465F-B6BC-D3A24A5B686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EA1C13-E9CE-4BAA-9661-321E74C3C0E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2FA3C0-94E3-4D29-B0CC-11C0C24066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38443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42C53DA1-AB90-4A0C-BBD6-F9FB778445B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32987520"/>
              </p:ext>
            </p:extLst>
          </p:nvPr>
        </p:nvGraphicFramePr>
        <p:xfrm>
          <a:off x="2513013" y="198437"/>
          <a:ext cx="6269037" cy="475524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4745868" imgH="3601180" progId="Prism8.Document">
                  <p:embed/>
                </p:oleObj>
              </mc:Choice>
              <mc:Fallback>
                <p:oleObj name="Prism 8" r:id="rId2" imgW="4745868" imgH="3601180" progId="Prism8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42C53DA1-AB90-4A0C-BBD6-F9FB778445B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513013" y="198437"/>
                        <a:ext cx="6269037" cy="475524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1F45CC8D-CE37-4AC2-B7F6-C063CA5F23F4}"/>
              </a:ext>
            </a:extLst>
          </p:cNvPr>
          <p:cNvSpPr txBox="1"/>
          <p:nvPr/>
        </p:nvSpPr>
        <p:spPr>
          <a:xfrm>
            <a:off x="242887" y="5029200"/>
            <a:ext cx="1170622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Figure S8:  </a:t>
            </a:r>
            <a:r>
              <a:rPr lang="en-GB" dirty="0"/>
              <a:t>H5 HI titres </a:t>
            </a:r>
            <a:r>
              <a:rPr lang="en-GB"/>
              <a:t>obtained from </a:t>
            </a:r>
            <a:r>
              <a:rPr lang="en-GB" dirty="0"/>
              <a:t>testing 40 duck sera sampled at IP40.  The three H5 HI antigens are indicated along the horizontal axis, with parentheses indicating the proportion (%) of H5 positive sera for each antigen (see Methods).  Error bars indicate the geometric mean HI titre for each antigen and the 95% confidence range.  The dotted horizontal line denotes the 1:16 positive cut-off for HI testing, while non-reactor sera (HI titre of &lt;1:2) are not shown.</a:t>
            </a:r>
          </a:p>
        </p:txBody>
      </p:sp>
    </p:spTree>
    <p:extLst>
      <p:ext uri="{BB962C8B-B14F-4D97-AF65-F5344CB8AC3E}">
        <p14:creationId xmlns:p14="http://schemas.microsoft.com/office/powerpoint/2010/main" val="20388879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90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8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lomka, Marek</dc:creator>
  <cp:lastModifiedBy>Marek Slomka</cp:lastModifiedBy>
  <cp:revision>1</cp:revision>
  <dcterms:created xsi:type="dcterms:W3CDTF">2022-09-16T15:28:31Z</dcterms:created>
  <dcterms:modified xsi:type="dcterms:W3CDTF">2023-05-16T17:54:53Z</dcterms:modified>
</cp:coreProperties>
</file>